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media/image10.jpeg" ContentType="image/jpe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57457-F017-4B78-AA67-F5A8D50E5E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4680" y="437004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E3D00-0240-4A3E-B163-4053A60EA5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53096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A40C0-EE58-473D-A1AD-E646E37B0E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8340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89176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468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8340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89176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3E824-DA91-45F6-AB42-8F39838749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47AB3F-78B5-4AFE-8A80-1578D568CC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33F3D76-48BF-42D8-8DB7-FF13A7F29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48B34FE-28DA-4929-B987-B75C91A866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3F268EC-7527-4A41-8B0A-01F0F1D7D6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5FD918-E38C-46ED-9096-A407FA6902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0" y="756720"/>
            <a:ext cx="7275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4273475-3C93-4B23-B15E-108E6E65E8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4575776-0B91-4B62-8888-C6AA0E070C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540DB-71DD-40F8-BFE4-4848760862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3096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901895-83A3-4E1B-B007-540E0B5567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C0422C2-7A76-458A-86A7-C30E9C09B6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274680" y="437004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4F370B5-CE70-48BD-B865-4F696E0080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53096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FEE1C07-40B3-48CB-9EFD-F2B949F044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08340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891760" y="199656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27468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08340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891760" y="4370040"/>
            <a:ext cx="26744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06388A-803B-46E0-A6EF-62CEA3863D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BEB89-52FB-489C-8CB3-B7CB97CD8F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8638F-4F2D-437A-8A54-5CF6A80F29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83534-C034-446D-8C14-776052BF1A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0" y="756720"/>
            <a:ext cx="7275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624F0-A81B-41AA-BB4D-2454300EA2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83986-3F05-4A17-BAB0-F66668F1CA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530960" y="437004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DE9CB-3F81-4EE6-8515-09C639427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530960" y="1996560"/>
            <a:ext cx="405324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4680" y="4370040"/>
            <a:ext cx="8305920" cy="216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F7F7F-68CA-4788-A9B2-9AB7C2436C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583320"/>
            <a:ext cx="1905120" cy="301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583320"/>
            <a:ext cx="2895840" cy="301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583320"/>
            <a:ext cx="1905120" cy="3016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6D6927-067D-4136-80EB-F70A4FAA246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2856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0" lang="en-US" sz="3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75EAD9-EF83-4A69-BE3F-460966FCB86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500" spc="-1" strike="noStrike">
              <a:solidFill>
                <a:srgbClr val="ffffff"/>
              </a:solidFill>
              <a:latin typeface="Arial"/>
            </a:endParaRPr>
          </a:p>
          <a:p>
            <a:pPr lvl="1" marL="412920" indent="0"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2" marL="825480" indent="88920" algn="ctr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3" marL="1236600" indent="135000" algn="ctr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4" marL="1649520" indent="179280" algn="ctr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5" marL="1649520" indent="1792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6" marL="1649520" indent="179280">
              <a:spcBef>
                <a:spcPts val="6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0.jpeg"/><Relationship Id="rId3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04920" y="837720"/>
            <a:ext cx="7162560" cy="26672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600"/>
            </a:br>
            <a:br>
              <a:rPr sz="3600"/>
            </a:br>
            <a:r>
              <a:rPr b="0" lang="en-US" sz="3600" spc="-1" strike="noStrike">
                <a:solidFill>
                  <a:srgbClr val="ffffff"/>
                </a:solidFill>
                <a:latin typeface="Arial"/>
              </a:rPr>
              <a:t>From </a:t>
            </a:r>
            <a:br>
              <a:rPr sz="3600"/>
            </a:br>
            <a:r>
              <a:rPr b="0" lang="en-US" sz="3600" spc="-1" strike="noStrike">
                <a:solidFill>
                  <a:srgbClr val="ffffff"/>
                </a:solidFill>
                <a:latin typeface="Arial"/>
              </a:rPr>
              <a:t>Computer Based Simulations                                  to 3D Virtual Learning</a:t>
            </a:r>
            <a:br>
              <a:rPr sz="3600"/>
            </a:br>
            <a:br>
              <a:rPr sz="3600"/>
            </a:br>
            <a:r>
              <a:rPr b="0" lang="en-US" sz="3600" spc="-1" strike="noStrike">
                <a:solidFill>
                  <a:srgbClr val="ffffff"/>
                </a:solidFill>
                <a:latin typeface="Arial"/>
              </a:rPr>
              <a:t>Building Bridges to Collaborative Learning Spaces</a:t>
            </a:r>
            <a:endParaRPr b="0" lang="en-US" sz="3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subTitle"/>
          </p:nvPr>
        </p:nvSpPr>
        <p:spPr>
          <a:xfrm>
            <a:off x="1828800" y="5486400"/>
            <a:ext cx="6781680" cy="1752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42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ffffff"/>
                </a:solidFill>
                <a:latin typeface="Arial"/>
              </a:rPr>
              <a:t>Diane D. Chapman, Sophia J. Stone, Dede Nelson</a:t>
            </a:r>
            <a:endParaRPr b="0" lang="en-US" sz="17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spcBef>
                <a:spcPts val="37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500" spc="-1" strike="noStrike">
                <a:solidFill>
                  <a:srgbClr val="ffffff"/>
                </a:solidFill>
                <a:latin typeface="Arial"/>
              </a:rPr>
              <a:t>North Carolina State University</a:t>
            </a:r>
            <a:endParaRPr b="0" lang="en-US" sz="15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Research Purpose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500" spc="-1" strike="noStrike">
                <a:solidFill>
                  <a:srgbClr val="000000"/>
                </a:solidFill>
                <a:latin typeface="Arial"/>
              </a:rPr>
              <a:t>To assess the effectiveness of the simulations an anonymous online survey was administered in April 2007 to elicit student perceptions of simulation effectiveness for their own learning and overall course effectivenes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urvey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11 Students completed an anonymous 23 item questionnaire via the web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 perceptions of simulation effectiveness in: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chieving course learning objectiv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pplication of course content/practi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Effectiveness of user interfa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ourse satisfaction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inding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609480" indent="-6094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chieving course learning objectiv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72% responded yes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marL="609480" indent="-6094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pplication of course content/practi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726"/>
              </a:spcBef>
              <a:buClr>
                <a:srgbClr val="000000"/>
              </a:buClr>
              <a:buFont typeface="Arial"/>
              <a:buChar char="-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75% left that question blank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-533520">
              <a:spcBef>
                <a:spcPts val="726"/>
              </a:spcBef>
              <a:buClr>
                <a:srgbClr val="000000"/>
              </a:buClr>
              <a:buFont typeface="Arial"/>
              <a:buChar char="-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(perhaps not enough time had elapsed from simulation use to application of course concepts)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990720" indent="0">
              <a:spcBef>
                <a:spcPts val="726"/>
              </a:spcBef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inding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Effectiveness of user interfa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72% (easy to navigate)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28% (distracting components)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ourse satisfaction/Recommend in future cours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26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50% gave a favorable response</a:t>
            </a: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7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26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rom Simulations to 3D VLE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" descr=""/>
          <p:cNvPicPr/>
          <p:nvPr/>
        </p:nvPicPr>
        <p:blipFill>
          <a:blip r:embed="rId2"/>
          <a:stretch/>
        </p:blipFill>
        <p:spPr>
          <a:xfrm>
            <a:off x="228600" y="1828800"/>
            <a:ext cx="5562720" cy="323388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3"/>
          <a:stretch/>
        </p:blipFill>
        <p:spPr>
          <a:xfrm>
            <a:off x="5181480" y="3895560"/>
            <a:ext cx="3219480" cy="2962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rom Simulations to 3D VLE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Research shows that offering simulations in               3D virtual learning environments has great potential for learning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More interactive, self-directed, and immersive learning experience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s can co-create content with their peers and instructor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Virtual World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ree-dimensional world where multiple people can interact in real-time while using avatars (virtual icons) as representations of themselves 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2"/>
          <a:stretch/>
        </p:blipFill>
        <p:spPr>
          <a:xfrm>
            <a:off x="1295280" y="3092400"/>
            <a:ext cx="6477120" cy="3765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Links to Educational Theory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onstructivism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Experiential learning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dult learning theory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ocial Presen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ituated Learning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9" name="" descr=""/>
          <p:cNvPicPr/>
          <p:nvPr/>
        </p:nvPicPr>
        <p:blipFill>
          <a:blip r:embed="rId2"/>
          <a:stretch/>
        </p:blipFill>
        <p:spPr>
          <a:xfrm>
            <a:off x="5029200" y="3659040"/>
            <a:ext cx="4114800" cy="319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20480" y="756720"/>
            <a:ext cx="727524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mulations in a 3D Virtual </a:t>
            </a:r>
            <a:br>
              <a:rPr sz="3200"/>
            </a:b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Learning Environ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900" spc="-1" strike="noStrike">
                <a:solidFill>
                  <a:srgbClr val="000000"/>
                </a:solidFill>
                <a:latin typeface="Arial"/>
              </a:rPr>
              <a:t>VOLT (Virtual Online Learning and   Teaching</a:t>
            </a:r>
            <a:r>
              <a:rPr b="1" lang="en-US" sz="2500" spc="-1" strike="noStrike">
                <a:solidFill>
                  <a:srgbClr val="000000"/>
                </a:solidFill>
                <a:latin typeface="Arial"/>
              </a:rPr>
              <a:t>) </a:t>
            </a:r>
            <a:r>
              <a:rPr b="1" i="1" lang="en-US" sz="2500" spc="-1" strike="noStrike">
                <a:solidFill>
                  <a:srgbClr val="cc6600"/>
                </a:solidFill>
                <a:latin typeface="Arial"/>
              </a:rPr>
              <a:t>http://litre.ncsu.edu/dfiles/VOLT.html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500" spc="-1" strike="noStrike">
                <a:solidFill>
                  <a:srgbClr val="000000"/>
                </a:solidFill>
                <a:latin typeface="Arial"/>
              </a:rPr>
              <a:t>Case based scenarios in a virtual learning environment, designed with Icaru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6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500" spc="-1" strike="noStrike">
                <a:solidFill>
                  <a:srgbClr val="000000"/>
                </a:solidFill>
                <a:latin typeface="Arial"/>
              </a:rPr>
              <a:t>Combines the pedagogical potential of virtual simulations with the appeal of game based learning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20480" y="756720"/>
            <a:ext cx="727524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mulations in a 3D Virtual </a:t>
            </a:r>
            <a:br>
              <a:rPr sz="3200"/>
            </a:b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Learning Environ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" descr=""/>
          <p:cNvPicPr/>
          <p:nvPr/>
        </p:nvPicPr>
        <p:blipFill>
          <a:blip r:embed="rId2"/>
          <a:stretch/>
        </p:blipFill>
        <p:spPr>
          <a:xfrm>
            <a:off x="762120" y="2057400"/>
            <a:ext cx="5715000" cy="4219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Learning by doing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228600" y="2057400"/>
            <a:ext cx="8229600" cy="4952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lnSpc>
                <a:spcPct val="100000"/>
              </a:lnSpc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 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100000"/>
              </a:lnSpc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“…</a:t>
            </a: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generally considered the most effective way to learn. The </a:t>
            </a:r>
            <a:r>
              <a:rPr b="1" i="1" lang="en-US" sz="2500" spc="-1" strike="noStrike">
                <a:solidFill>
                  <a:srgbClr val="cc6600"/>
                </a:solidFill>
                <a:latin typeface="Arial Unicode MS"/>
              </a:rPr>
              <a:t>Internet</a:t>
            </a: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 and a variety of </a:t>
            </a:r>
            <a:r>
              <a:rPr b="1" i="1" lang="en-US" sz="2500" spc="-1" strike="noStrike">
                <a:solidFill>
                  <a:srgbClr val="cc6600"/>
                </a:solidFill>
                <a:latin typeface="Arial Unicode MS"/>
              </a:rPr>
              <a:t>emerging communication</a:t>
            </a: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, </a:t>
            </a:r>
            <a:r>
              <a:rPr b="1" i="1" lang="en-US" sz="2500" spc="-1" strike="noStrike">
                <a:solidFill>
                  <a:srgbClr val="cc6600"/>
                </a:solidFill>
                <a:latin typeface="Arial Unicode MS"/>
              </a:rPr>
              <a:t>visualization</a:t>
            </a: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, and </a:t>
            </a:r>
            <a:r>
              <a:rPr b="1" i="1" lang="en-US" sz="2500" spc="-1" strike="noStrike">
                <a:solidFill>
                  <a:srgbClr val="cc6600"/>
                </a:solidFill>
                <a:latin typeface="Arial Unicode MS"/>
              </a:rPr>
              <a:t>simulation</a:t>
            </a:r>
            <a:r>
              <a:rPr b="0" i="1" lang="en-US" sz="2500" spc="-1" strike="noStrike">
                <a:solidFill>
                  <a:srgbClr val="000000"/>
                </a:solidFill>
                <a:latin typeface="Arial Unicode MS"/>
              </a:rPr>
              <a:t> technologies now make it possible to offer students authentic learning experiences ranging from experimentation to real-world problem solving."</a:t>
            </a:r>
            <a:r>
              <a:rPr b="0" lang="en-US" sz="2500" spc="-1" strike="noStrike">
                <a:solidFill>
                  <a:srgbClr val="000000"/>
                </a:solidFill>
                <a:latin typeface="Arial Unicode MS"/>
              </a:rPr>
              <a:t>                    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 algn="r">
              <a:lnSpc>
                <a:spcPct val="10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 Unicode MS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 Unicode MS"/>
              </a:rPr>
              <a:t>--Lombardi &amp; Oblinger (2007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Lessons Learned: Benefit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Both simulations and case based scenarios  build upon sound educational theory (learning styles, learning theories)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Both build problem solving-skill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Role-playing and experiential learning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Lessons Learned: Challeng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Barriers associated with purchasing 3</a:t>
            </a:r>
            <a:r>
              <a:rPr b="0" lang="en-US" sz="2500" spc="-1" strike="noStrike" baseline="30000">
                <a:solidFill>
                  <a:srgbClr val="000000"/>
                </a:solidFill>
                <a:latin typeface="Arial"/>
              </a:rPr>
              <a:t>rd</a:t>
            </a: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 party content (simulations)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Resource requirements to develop 3D scenario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s want real-time audio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s want to understand why a specific technology is being used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he value of a technology is not always obvious to student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onsiderations 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pecific learning outcomes need to drive choice of learning technology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Does immersion and role-play enhance the learning experience?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Resources (time, money, talent) to develop in-house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upport available (technical, training)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Ethical, accessibility, and usability concerns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Ownership of content and peer review 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5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Overview</a:t>
            </a: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707544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5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&amp;D Online constantly seeks innovative ways to engage and immerse students in learning</a:t>
            </a:r>
            <a:br>
              <a:rPr sz="2200"/>
            </a:b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2600" spc="-1" strike="noStrike" baseline="30000">
                <a:solidFill>
                  <a:srgbClr val="000000"/>
                </a:solidFill>
                <a:latin typeface="Arial"/>
              </a:rPr>
              <a:t>rd</a:t>
            </a: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 party purchased simulations</a:t>
            </a:r>
            <a:br>
              <a:rPr sz="2600"/>
            </a:b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4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ase based scenarios in a </a:t>
            </a:r>
            <a:br>
              <a:rPr sz="2600"/>
            </a:b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3D Virtual learning environment  </a:t>
            </a:r>
            <a:br>
              <a:rPr sz="2600"/>
            </a:b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known as (VOLT)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" descr=""/>
          <p:cNvPicPr/>
          <p:nvPr/>
        </p:nvPicPr>
        <p:blipFill>
          <a:blip r:embed="rId2"/>
          <a:stretch/>
        </p:blipFill>
        <p:spPr>
          <a:xfrm>
            <a:off x="6350040" y="2816280"/>
            <a:ext cx="2019240" cy="328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25080" y="756720"/>
            <a:ext cx="67611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200" spc="-1" strike="noStrike">
                <a:solidFill>
                  <a:srgbClr val="000000"/>
                </a:solidFill>
                <a:latin typeface="Arial"/>
              </a:rPr>
              <a:t>Building a Culture for Sustaining Change</a:t>
            </a:r>
            <a:br>
              <a:rPr sz="22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ample Simulation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685800" y="1981080"/>
            <a:ext cx="5715000" cy="4276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25080" y="756720"/>
            <a:ext cx="67611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200" spc="-1" strike="noStrike">
                <a:solidFill>
                  <a:srgbClr val="000000"/>
                </a:solidFill>
                <a:latin typeface="Arial"/>
              </a:rPr>
              <a:t>Building a Culture for Sustaining Change</a:t>
            </a:r>
            <a:br>
              <a:rPr sz="22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ample Simulation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2"/>
          <a:stretch/>
        </p:blipFill>
        <p:spPr>
          <a:xfrm>
            <a:off x="762120" y="2362320"/>
            <a:ext cx="5715000" cy="3943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325080" y="756720"/>
            <a:ext cx="67611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200" spc="-1" strike="noStrike">
                <a:solidFill>
                  <a:srgbClr val="000000"/>
                </a:solidFill>
                <a:latin typeface="Arial"/>
              </a:rPr>
              <a:t>Building a Culture for Sustaining Change</a:t>
            </a:r>
            <a:br>
              <a:rPr sz="2200"/>
            </a:b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ample Simulation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" descr=""/>
          <p:cNvPicPr/>
          <p:nvPr/>
        </p:nvPicPr>
        <p:blipFill>
          <a:blip r:embed="rId2"/>
          <a:stretch/>
        </p:blipFill>
        <p:spPr>
          <a:xfrm>
            <a:off x="609480" y="2362320"/>
            <a:ext cx="5715000" cy="4000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ase Based Simulations</a:t>
            </a: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an provide authentic learning opportunities that allow students to: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Engage in real-world task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Tackle ill-defined problem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View problem from multiple perspectiv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Experiment with cause and effect of different decision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ase Based Simulations</a:t>
            </a: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5029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6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 participation can result in:</a:t>
            </a:r>
            <a:br>
              <a:rPr sz="2500"/>
            </a:b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“</a:t>
            </a: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hands-on practice with situations they would not likely experience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valuable decision-making practice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recognition of cause and effect of specific management decisions/strategie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application of theory to practice in a real-world situation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6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268200" y="756720"/>
            <a:ext cx="7275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The Pilot Study: Backgroun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274680" y="1996560"/>
            <a:ext cx="8305920" cy="4543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pring 2007: EAC 584 piloted 2 simulations, </a:t>
            </a:r>
            <a:r>
              <a:rPr b="0" i="1" lang="en-US" sz="2500" spc="-1" strike="noStrike">
                <a:solidFill>
                  <a:srgbClr val="000000"/>
                </a:solidFill>
                <a:latin typeface="Arial"/>
              </a:rPr>
              <a:t>Thinking Critically</a:t>
            </a: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2500" spc="-1" strike="noStrike">
                <a:solidFill>
                  <a:srgbClr val="000000"/>
                </a:solidFill>
                <a:latin typeface="Arial"/>
              </a:rPr>
              <a:t>Thinking Ethically</a:t>
            </a: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s completed simulations and engaged in online discussion forum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6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Students had unlimited access to simulations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7T16:45:38Z</dcterms:created>
  <dc:creator>Sophia Stone</dc:creator>
  <dc:description/>
  <dc:language>en-US</dc:language>
  <cp:lastModifiedBy>Diane Chapman</cp:lastModifiedBy>
  <dcterms:modified xsi:type="dcterms:W3CDTF">2008-03-14T05:21:52Z</dcterms:modified>
  <cp:revision>22</cp:revision>
  <dc:subject/>
  <dc:title>Case Based Simulations </dc:title>
</cp:coreProperties>
</file>